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EBC993-53D3-4EF0-8210-CC4EF6A7BDC1}" type="slidenum">
              <a:rPr b="0" lang="pt-B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pt-B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B6D580D-A738-4040-B988-72940874A415}" type="slidenum">
              <a:rPr b="0" lang="pt-B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75F75D-0807-4A53-B6B8-503796E30F7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6AE736-F3DC-4560-95E2-D1D0C09040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DEB98C-127B-4CE0-816D-DC079B667DC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CFF655-8EC7-4005-A4B9-C795275A0A6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FD6727-23E1-4CC2-BD1F-CD6046BC8C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FD57E1-8DAC-432B-9920-B43ACE58B2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C217A8-542A-4C38-A0F6-D7AC1899B7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B16244-75D0-46F7-8F0C-3C7CBA2814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6AD189-EA2D-4FB1-AA9C-54FB3536EE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64E7AC-A084-42D3-8298-A2CE9FA8A9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1A285A-5E78-49D6-8DB3-41195E1E57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8E6F94-375F-4498-A403-D19958ED89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91AA45-C7E3-4F85-BBB6-F6A812E3EA94}" type="slidenum">
              <a:rPr b="0" lang="pt-B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Imagem 31" descr=""/>
          <p:cNvPicPr/>
          <p:nvPr/>
        </p:nvPicPr>
        <p:blipFill>
          <a:blip r:embed="rId1"/>
          <a:srcRect l="0" t="16835" r="7149" b="15328"/>
          <a:stretch/>
        </p:blipFill>
        <p:spPr>
          <a:xfrm>
            <a:off x="34920" y="1366920"/>
            <a:ext cx="9020160" cy="3141720"/>
          </a:xfrm>
          <a:prstGeom prst="rect">
            <a:avLst/>
          </a:prstGeom>
          <a:ln w="0">
            <a:noFill/>
          </a:ln>
        </p:spPr>
      </p:pic>
      <p:sp>
        <p:nvSpPr>
          <p:cNvPr id="49" name="Rectangle 3"/>
          <p:cNvSpPr/>
          <p:nvPr/>
        </p:nvSpPr>
        <p:spPr>
          <a:xfrm>
            <a:off x="0" y="5590440"/>
            <a:ext cx="9144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Calibri"/>
              </a:rPr>
              <a:t>Figure S3: Cladogram of species </a:t>
            </a:r>
            <a:r>
              <a:rPr b="0" lang="en-US" sz="1000" spc="-1" strike="noStrike">
                <a:solidFill>
                  <a:srgbClr val="222222"/>
                </a:solidFill>
                <a:latin typeface="Times New Roman"/>
                <a:ea typeface="Calibri"/>
              </a:rPr>
              <a:t>built from the alignment of APE4 protein,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Calibri"/>
              </a:rPr>
              <a:t>(MegaAlign / Core Lasergene suite DNASTAR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  <a:ea typeface="Calibri"/>
              </a:rPr>
              <a:t>®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Calibri"/>
              </a:rPr>
              <a:t>). See supplementary Table ST2 for access number entrie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19T10:58:13Z</dcterms:created>
  <dc:creator>Marcelo</dc:creator>
  <dc:description/>
  <dc:language>en-US</dc:language>
  <cp:lastModifiedBy>Marcelo</cp:lastModifiedBy>
  <dcterms:modified xsi:type="dcterms:W3CDTF">2016-12-20T15:59:51Z</dcterms:modified>
  <cp:revision>18</cp:revision>
  <dc:subject/>
  <dc:title>Slide 1</dc:title>
</cp:coreProperties>
</file>